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EAA44"/>
    <a:srgbClr val="84CC52"/>
    <a:srgbClr val="DE42DC"/>
    <a:srgbClr val="FF4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854"/>
    <p:restoredTop sz="94648"/>
  </p:normalViewPr>
  <p:slideViewPr>
    <p:cSldViewPr snapToGrid="0" snapToObjects="1">
      <p:cViewPr varScale="1">
        <p:scale>
          <a:sx n="112" d="100"/>
          <a:sy n="112" d="100"/>
        </p:scale>
        <p:origin x="1040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A4FFFC-7DF9-4A47-8340-BBD6BCDB4E3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EA38DFD-D456-0246-BEA8-71C809B58A0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3EDCDC-269C-7A46-9AE5-CBCC3C8880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3E417C-52EC-9D47-AB8D-64002AA635E6}" type="datetimeFigureOut">
              <a:rPr lang="en-US" smtClean="0"/>
              <a:t>7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61B375-868B-D044-A612-FD8D487920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511DA1-ADFF-BC44-951F-1F30DC999E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66CC1-9904-F041-8A79-AC90CDDA8B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69096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23A133-14D0-454A-BC29-447B0B064B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7019A4C-AFC9-584E-A59B-EEE8A93F0D6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911E57-DAEA-804A-B913-C811A1C645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3E417C-52EC-9D47-AB8D-64002AA635E6}" type="datetimeFigureOut">
              <a:rPr lang="en-US" smtClean="0"/>
              <a:t>7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977AC6-2163-FA4F-A8AC-0DCFE656A3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DC9A6B-003E-8344-B57D-26E217085C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66CC1-9904-F041-8A79-AC90CDDA8B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87038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60A7944-47A9-D744-A5C3-AC411931321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9EFBB3F-A357-7849-B781-CCCF66C2335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2E7BCC-E78C-3349-8D49-70AD3C1DF9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3E417C-52EC-9D47-AB8D-64002AA635E6}" type="datetimeFigureOut">
              <a:rPr lang="en-US" smtClean="0"/>
              <a:t>7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99BF52-B800-3F43-B1CD-89FD292B7D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F5E594-FAF1-9943-8DE6-04BAB3EF05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66CC1-9904-F041-8A79-AC90CDDA8B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72845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2BFEC0-8AB8-B040-B9F6-46CD828DA1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49D7184-C5B5-D243-8419-383310EEEFC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31FC52-39BD-B04D-B3C9-20CFA37B78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3E417C-52EC-9D47-AB8D-64002AA635E6}" type="datetimeFigureOut">
              <a:rPr lang="en-US" smtClean="0"/>
              <a:t>7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2404F1-2845-9740-9C8E-166109537C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BCF884-C453-DF42-BED0-666860C809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66CC1-9904-F041-8A79-AC90CDDA8B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99376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417069-307C-C149-9A39-B013D48349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08D9DF2-44A0-C74D-8459-9946021DDC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20FFFD-011E-244A-939C-6D0F6CF02B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3E417C-52EC-9D47-AB8D-64002AA635E6}" type="datetimeFigureOut">
              <a:rPr lang="en-US" smtClean="0"/>
              <a:t>7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113DB1-CB9B-9346-B852-B11F2D31C7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361697-5737-A14D-BBC4-B94052535A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66CC1-9904-F041-8A79-AC90CDDA8B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80886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54232C-637C-C644-89B5-E55EFE8EB7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01DF76C-C10B-1048-B015-E0AE11029B7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D388A6B-064F-1247-8E69-F3FB0ED2D49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DFAB90C-DE6E-8646-B2EA-0481007C3B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3E417C-52EC-9D47-AB8D-64002AA635E6}" type="datetimeFigureOut">
              <a:rPr lang="en-US" smtClean="0"/>
              <a:t>7/1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C02685A-4D9D-014F-92EA-FF355D30B2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E6B3C62-A5F7-DD4A-BFC6-513DB9EFB2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66CC1-9904-F041-8A79-AC90CDDA8B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00506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335406-86F1-2345-96BF-F2B56346AD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C70AC6F-5B53-4C45-BB71-3DDC1EDC76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DC6944D-A81D-4748-99C3-91625974B90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2E517DC-DB4C-7349-B212-83ADE1C9AF0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12A6F7E-F7AF-1A41-AC56-94AA7A78C62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0556C79-1EE0-CA40-BD66-B2570F9835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3E417C-52EC-9D47-AB8D-64002AA635E6}" type="datetimeFigureOut">
              <a:rPr lang="en-US" smtClean="0"/>
              <a:t>7/13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69FACA0-1B7C-344D-8176-9DF6A7D345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1BA66F7-1518-F34C-9CF3-3ABC50D199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66CC1-9904-F041-8A79-AC90CDDA8B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19250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EEB615-4E04-934D-AC8B-2416CD6FDE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5297097-841D-714F-A69C-4F20462BDD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3E417C-52EC-9D47-AB8D-64002AA635E6}" type="datetimeFigureOut">
              <a:rPr lang="en-US" smtClean="0"/>
              <a:t>7/13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8159151-8986-074E-B426-696717A5D2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88CFDB3-3A1B-8749-888B-D5B68098D0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66CC1-9904-F041-8A79-AC90CDDA8B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12542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654FD4C-74DF-8C4D-A3B9-E3E42022CB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3E417C-52EC-9D47-AB8D-64002AA635E6}" type="datetimeFigureOut">
              <a:rPr lang="en-US" smtClean="0"/>
              <a:t>7/13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349DC06-AADA-424D-A953-59763C5B5B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CD9A82B-40F4-B844-A100-2EF0224C67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66CC1-9904-F041-8A79-AC90CDDA8B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19319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21C528-5012-0A43-9068-EBA9200D5C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B4BBCBB-A1FC-154A-900A-D07632160E8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3E135F4-B9C6-3342-8833-32996CF7139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3BE9F04-F2C0-4F4B-A9DE-25FB46F3EA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3E417C-52EC-9D47-AB8D-64002AA635E6}" type="datetimeFigureOut">
              <a:rPr lang="en-US" smtClean="0"/>
              <a:t>7/1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5AD2705-5C32-6045-B920-8298D40C16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3E841E-F975-1C45-B0CA-D043D65BB0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66CC1-9904-F041-8A79-AC90CDDA8B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09040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900F0B-D5AB-E64F-9AF3-156A932324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11AEE7B-B6CB-214D-A0FF-FA268114332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F41C11D-1D64-E94D-86AF-3027B4CB845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6F4D12D-0B9C-8942-8258-ADC066B151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3E417C-52EC-9D47-AB8D-64002AA635E6}" type="datetimeFigureOut">
              <a:rPr lang="en-US" smtClean="0"/>
              <a:t>7/1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74C805A-07A5-D041-A99E-9001A9CE2F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EFD8309-8E65-7340-A600-26C89D71CA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66CC1-9904-F041-8A79-AC90CDDA8B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40702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891FB64-1CC9-F04B-A8B0-8AED2E31F1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F6FEE36-A05E-814D-B9B6-26BD320B1E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B73CC6-3EA1-0E46-A18C-FA689E45DAF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3E417C-52EC-9D47-AB8D-64002AA635E6}" type="datetimeFigureOut">
              <a:rPr lang="en-US" smtClean="0"/>
              <a:t>7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2A6529-F707-DE48-B0FD-059D8D5963A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CFE333-4011-3C45-A66D-2C4DA9A4BA7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366CC1-9904-F041-8A79-AC90CDDA8B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6549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95BA0BC-F15E-1845-8A49-894A7D23F0BE}"/>
              </a:ext>
            </a:extLst>
          </p:cNvPr>
          <p:cNvSpPr txBox="1"/>
          <p:nvPr/>
        </p:nvSpPr>
        <p:spPr>
          <a:xfrm>
            <a:off x="8403220" y="1990846"/>
            <a:ext cx="3113590" cy="35394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egend:</a:t>
            </a:r>
          </a:p>
          <a:p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b="1" i="1" dirty="0">
                <a:solidFill>
                  <a:schemeClr val="accent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E – </a:t>
            </a:r>
            <a:r>
              <a:rPr lang="en-US" sz="1400" dirty="0">
                <a:solidFill>
                  <a:schemeClr val="accent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osure variable</a:t>
            </a:r>
          </a:p>
          <a:p>
            <a:endParaRPr lang="en-US" sz="1400" b="1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b="1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– Outcome variable</a:t>
            </a:r>
          </a:p>
          <a:p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                 Biasing path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               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                 Causal path</a:t>
            </a:r>
          </a:p>
          <a:p>
            <a:endParaRPr lang="en-PH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PH" sz="1400" dirty="0">
                <a:latin typeface="Arial" panose="020B0604020202020204" pitchFamily="34" charset="0"/>
                <a:cs typeface="Arial" panose="020B0604020202020204" pitchFamily="34" charset="0"/>
              </a:rPr>
              <a:t>white nodes = ancestors of exposure and outcome</a:t>
            </a:r>
          </a:p>
          <a:p>
            <a:endParaRPr lang="en-PH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PH" sz="1400" dirty="0">
                <a:latin typeface="Arial" panose="020B0604020202020204" pitchFamily="34" charset="0"/>
                <a:cs typeface="Arial" panose="020B0604020202020204" pitchFamily="34" charset="0"/>
              </a:rPr>
              <a:t>blue node = ancestor of the outcome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        </a:t>
            </a:r>
          </a:p>
          <a:p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7503BE16-1A55-0046-AD24-26CB1A761556}"/>
              </a:ext>
            </a:extLst>
          </p:cNvPr>
          <p:cNvCxnSpPr>
            <a:cxnSpLocks/>
          </p:cNvCxnSpPr>
          <p:nvPr/>
        </p:nvCxnSpPr>
        <p:spPr>
          <a:xfrm>
            <a:off x="8518967" y="3429000"/>
            <a:ext cx="70335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ECC74B23-A57F-1745-AD14-92AE4FA59D98}"/>
              </a:ext>
            </a:extLst>
          </p:cNvPr>
          <p:cNvCxnSpPr>
            <a:cxnSpLocks/>
          </p:cNvCxnSpPr>
          <p:nvPr/>
        </p:nvCxnSpPr>
        <p:spPr>
          <a:xfrm>
            <a:off x="8518967" y="3880413"/>
            <a:ext cx="703355" cy="0"/>
          </a:xfrm>
          <a:prstGeom prst="line">
            <a:avLst/>
          </a:prstGeom>
          <a:ln w="28575">
            <a:solidFill>
              <a:srgbClr val="6EAA4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4D43D714-DFFC-D24A-A8E2-4439E90A640B}"/>
              </a:ext>
            </a:extLst>
          </p:cNvPr>
          <p:cNvSpPr txBox="1"/>
          <p:nvPr/>
        </p:nvSpPr>
        <p:spPr>
          <a:xfrm>
            <a:off x="219919" y="6093804"/>
            <a:ext cx="1152838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PH" sz="1200" dirty="0">
                <a:latin typeface="Arial" panose="020B0604020202020204" pitchFamily="34" charset="0"/>
                <a:cs typeface="Arial" panose="020B0604020202020204" pitchFamily="34" charset="0"/>
              </a:rPr>
              <a:t>Causal diagram of the relationship between Anticipated Stigma and HIV Self-testing preference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EC34C198-081E-8943-8D97-DA87CB4A5FE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9919" y="857250"/>
            <a:ext cx="8128000" cy="5143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90619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95BA0BC-F15E-1845-8A49-894A7D23F0BE}"/>
              </a:ext>
            </a:extLst>
          </p:cNvPr>
          <p:cNvSpPr txBox="1"/>
          <p:nvPr/>
        </p:nvSpPr>
        <p:spPr>
          <a:xfrm>
            <a:off x="8403220" y="1990846"/>
            <a:ext cx="3113590" cy="35394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egend:</a:t>
            </a:r>
          </a:p>
          <a:p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b="1" i="1" dirty="0">
                <a:solidFill>
                  <a:schemeClr val="accent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E – </a:t>
            </a:r>
            <a:r>
              <a:rPr lang="en-US" sz="1400" dirty="0">
                <a:solidFill>
                  <a:schemeClr val="accent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osure variable</a:t>
            </a:r>
          </a:p>
          <a:p>
            <a:endParaRPr lang="en-US" sz="1400" b="1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b="1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– Outcome variable</a:t>
            </a:r>
          </a:p>
          <a:p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                 Biasing path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               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                 Causal path</a:t>
            </a:r>
          </a:p>
          <a:p>
            <a:endParaRPr lang="en-PH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PH" sz="1400" dirty="0">
                <a:latin typeface="Arial" panose="020B0604020202020204" pitchFamily="34" charset="0"/>
                <a:cs typeface="Arial" panose="020B0604020202020204" pitchFamily="34" charset="0"/>
              </a:rPr>
              <a:t>white nodes = ancestors of exposure and outcome</a:t>
            </a:r>
          </a:p>
          <a:p>
            <a:endParaRPr lang="en-PH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PH" sz="1400" dirty="0">
                <a:latin typeface="Arial" panose="020B0604020202020204" pitchFamily="34" charset="0"/>
                <a:cs typeface="Arial" panose="020B0604020202020204" pitchFamily="34" charset="0"/>
              </a:rPr>
              <a:t>blue node = ancestor of the outcome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        </a:t>
            </a:r>
          </a:p>
          <a:p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7503BE16-1A55-0046-AD24-26CB1A761556}"/>
              </a:ext>
            </a:extLst>
          </p:cNvPr>
          <p:cNvCxnSpPr>
            <a:cxnSpLocks/>
          </p:cNvCxnSpPr>
          <p:nvPr/>
        </p:nvCxnSpPr>
        <p:spPr>
          <a:xfrm>
            <a:off x="8518967" y="3429000"/>
            <a:ext cx="70335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ECC74B23-A57F-1745-AD14-92AE4FA59D98}"/>
              </a:ext>
            </a:extLst>
          </p:cNvPr>
          <p:cNvCxnSpPr>
            <a:cxnSpLocks/>
          </p:cNvCxnSpPr>
          <p:nvPr/>
        </p:nvCxnSpPr>
        <p:spPr>
          <a:xfrm>
            <a:off x="8518967" y="3880413"/>
            <a:ext cx="703355" cy="0"/>
          </a:xfrm>
          <a:prstGeom prst="line">
            <a:avLst/>
          </a:prstGeom>
          <a:ln w="28575">
            <a:solidFill>
              <a:srgbClr val="6EAA4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4D43D714-DFFC-D24A-A8E2-4439E90A640B}"/>
              </a:ext>
            </a:extLst>
          </p:cNvPr>
          <p:cNvSpPr txBox="1"/>
          <p:nvPr/>
        </p:nvSpPr>
        <p:spPr>
          <a:xfrm>
            <a:off x="219919" y="6093804"/>
            <a:ext cx="1152838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PH" sz="1200" dirty="0">
                <a:latin typeface="Arial" panose="020B0604020202020204" pitchFamily="34" charset="0"/>
                <a:cs typeface="Arial" panose="020B0604020202020204" pitchFamily="34" charset="0"/>
              </a:rPr>
              <a:t>Causal diagram of the relationship between Provider Mistrust and HIV Self-testing preference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49439C0-6977-B241-BC9C-AE89AACDDC5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7347" y="567883"/>
            <a:ext cx="8128000" cy="5143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788143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4D43D714-DFFC-D24A-A8E2-4439E90A640B}"/>
              </a:ext>
            </a:extLst>
          </p:cNvPr>
          <p:cNvSpPr txBox="1"/>
          <p:nvPr/>
        </p:nvSpPr>
        <p:spPr>
          <a:xfrm>
            <a:off x="219919" y="6093804"/>
            <a:ext cx="1152838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PH" sz="1200" dirty="0">
                <a:latin typeface="Arial" panose="020B0604020202020204" pitchFamily="34" charset="0"/>
                <a:cs typeface="Arial" panose="020B0604020202020204" pitchFamily="34" charset="0"/>
              </a:rPr>
              <a:t>Causal diagram of the interaction of Anticipated stigma and Provider Mistrust in relation to HIV Self-testing preference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D877BBA-9407-6845-A7E8-9104DFF2845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817" r="11559"/>
          <a:stretch/>
        </p:blipFill>
        <p:spPr>
          <a:xfrm>
            <a:off x="176924" y="405114"/>
            <a:ext cx="7818823" cy="511601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8589CFC7-0424-E24C-8699-84C562C9168A}"/>
              </a:ext>
            </a:extLst>
          </p:cNvPr>
          <p:cNvSpPr txBox="1"/>
          <p:nvPr/>
        </p:nvSpPr>
        <p:spPr>
          <a:xfrm>
            <a:off x="8403220" y="1990846"/>
            <a:ext cx="3113590" cy="35394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egend:</a:t>
            </a:r>
          </a:p>
          <a:p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b="1" i="1" dirty="0">
                <a:solidFill>
                  <a:schemeClr val="accent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E – </a:t>
            </a:r>
            <a:r>
              <a:rPr lang="en-US" sz="1400" dirty="0">
                <a:solidFill>
                  <a:schemeClr val="accent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osure variable</a:t>
            </a:r>
          </a:p>
          <a:p>
            <a:endParaRPr lang="en-US" sz="1400" b="1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b="1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– Outcome variable</a:t>
            </a:r>
          </a:p>
          <a:p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                 Biasing path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               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                 Causal path</a:t>
            </a:r>
          </a:p>
          <a:p>
            <a:endParaRPr lang="en-PH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PH" sz="1400" dirty="0">
                <a:latin typeface="Arial" panose="020B0604020202020204" pitchFamily="34" charset="0"/>
                <a:cs typeface="Arial" panose="020B0604020202020204" pitchFamily="34" charset="0"/>
              </a:rPr>
              <a:t>white nodes = ancestors of exposure and outcome</a:t>
            </a:r>
          </a:p>
          <a:p>
            <a:endParaRPr lang="en-PH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PH" sz="1400" dirty="0">
                <a:latin typeface="Arial" panose="020B0604020202020204" pitchFamily="34" charset="0"/>
                <a:cs typeface="Arial" panose="020B0604020202020204" pitchFamily="34" charset="0"/>
              </a:rPr>
              <a:t>blue node = ancestor of the outcome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        </a:t>
            </a:r>
          </a:p>
          <a:p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7EFCC78B-9836-634E-B766-66B015E43792}"/>
              </a:ext>
            </a:extLst>
          </p:cNvPr>
          <p:cNvCxnSpPr>
            <a:cxnSpLocks/>
          </p:cNvCxnSpPr>
          <p:nvPr/>
        </p:nvCxnSpPr>
        <p:spPr>
          <a:xfrm>
            <a:off x="8518967" y="3429000"/>
            <a:ext cx="70335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9DED2E82-5DD5-0242-8BA5-36E99F7B4E87}"/>
              </a:ext>
            </a:extLst>
          </p:cNvPr>
          <p:cNvCxnSpPr>
            <a:cxnSpLocks/>
          </p:cNvCxnSpPr>
          <p:nvPr/>
        </p:nvCxnSpPr>
        <p:spPr>
          <a:xfrm>
            <a:off x="8518967" y="3880413"/>
            <a:ext cx="703355" cy="0"/>
          </a:xfrm>
          <a:prstGeom prst="line">
            <a:avLst/>
          </a:prstGeom>
          <a:ln w="28575">
            <a:solidFill>
              <a:srgbClr val="6EAA4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436896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53</TotalTime>
  <Words>140</Words>
  <Application>Microsoft Macintosh PowerPoint</Application>
  <PresentationFormat>Widescreen</PresentationFormat>
  <Paragraphs>45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livia Sison</dc:creator>
  <cp:lastModifiedBy>Olivia Sison</cp:lastModifiedBy>
  <cp:revision>5</cp:revision>
  <dcterms:created xsi:type="dcterms:W3CDTF">2022-02-08T03:02:27Z</dcterms:created>
  <dcterms:modified xsi:type="dcterms:W3CDTF">2022-07-13T06:10:15Z</dcterms:modified>
</cp:coreProperties>
</file>